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6" d="100"/>
          <a:sy n="46" d="100"/>
        </p:scale>
        <p:origin x="-1548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2AA2DB-4457-4FCA-B7BB-7165580DF147}" type="datetimeFigureOut">
              <a:rPr lang="en-US" smtClean="0"/>
              <a:t>2011-04-0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2E288-C09F-41C7-8A54-F67419FF6EC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139" name="Group 2323"/>
          <p:cNvGraphicFramePr>
            <a:graphicFrameLocks noGrp="1"/>
          </p:cNvGraphicFramePr>
          <p:nvPr/>
        </p:nvGraphicFramePr>
        <p:xfrm>
          <a:off x="26988" y="488950"/>
          <a:ext cx="6858000" cy="9150352"/>
        </p:xfrm>
        <a:graphic>
          <a:graphicData uri="http://schemas.openxmlformats.org/drawingml/2006/table">
            <a:tbl>
              <a:tblPr/>
              <a:tblGrid>
                <a:gridCol w="1708150"/>
                <a:gridCol w="1373187"/>
                <a:gridCol w="2281238"/>
                <a:gridCol w="1495425"/>
              </a:tblGrid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pecies</a:t>
                      </a:r>
                      <a:endParaRPr kumimoji="0" lang="en-US" altLang="zh-TW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cession/ Reference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pecies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cession/ Reference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AA0412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THRI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030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AA04466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THR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64458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1433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PTHR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6880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55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A8081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us scrofa PTHR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99954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Q6308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108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 laevi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F1693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1358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idibunda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L2683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Sus scrofa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41535 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ncorhynchus mykis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U2949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X5608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PAC1A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D3569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 laevis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D56956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PAC1B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D38842 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idibunda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F7457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C1569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rotopterus dolloi PRP-PACA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CI25366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1346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PRP-PACAP 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DARP0000003324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55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I62944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PRP-PACAP II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ENSDARP0000007598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VPAC2B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386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Clarias macrocephalus PRP-PACAP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新細明體" pitchFamily="18" charset="-120"/>
                        </a:rPr>
                        <a:t>CAA55684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VPAC2A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386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Ictalurus punctatus PRP-PACAP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</a:rPr>
                        <a:t>AAK6697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X56943 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583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ugulosa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(58)</a:t>
                      </a:r>
                      <a:endParaRPr kumimoji="0" lang="en-US" altLang="zh-TW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01283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3373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M2815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353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A61284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VPAC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58934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 laevi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79183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B0545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99069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55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W6513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eleagris gallopavo PHI-VIP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45644 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VPAC1A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2588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PHI-VIPa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(59)</a:t>
                      </a:r>
                      <a:endParaRPr kumimoji="0" lang="en-US" altLang="zh-TW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Takifugu rubripes VPAC1B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C8258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PHI-VIPb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(59)</a:t>
                      </a:r>
                      <a:endParaRPr kumimoji="0" lang="en-US" altLang="zh-TW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P5868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J5597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na ridibunda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D0360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Danio rerio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J55980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461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Xenopus laevi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BJ5597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5833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84789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VPAC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681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6656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SCTR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12322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441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55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SCTR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11237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 norvegicus GHRH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11376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Oryctolagus cuniculus SCTR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7549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rassius auratus proglucagon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P79695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Bos taurus SCTR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0109249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Gallus gallus proglucagon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CAA68827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SCTR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A64949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Mus musculus proglucagon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032126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40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Rattus</a:t>
                      </a:r>
                      <a:r>
                        <a:rPr kumimoji="0" lang="en-US" altLang="zh-TW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</a:t>
                      </a:r>
                      <a:r>
                        <a:rPr kumimoji="0" lang="en-US" altLang="zh-TW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orvegicus</a:t>
                      </a:r>
                      <a:r>
                        <a:rPr kumimoji="0" lang="en-US" altLang="zh-TW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 PTHRII</a:t>
                      </a:r>
                      <a:endParaRPr kumimoji="0" lang="en-US" altLang="zh-TW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NP_112351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Homo sapiens proglucagon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TW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新細明體" pitchFamily="18" charset="-120"/>
                          <a:cs typeface="Times New Roman" pitchFamily="18" charset="0"/>
                        </a:rPr>
                        <a:t>AAH05278</a:t>
                      </a:r>
                      <a:endParaRPr kumimoji="0" lang="en-US" altLang="zh-TW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新細明體" pitchFamily="18" charset="-120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6</Words>
  <Application>Microsoft Office PowerPoint</Application>
  <PresentationFormat>A4 Paper (210x297 mm)</PresentationFormat>
  <Paragraphs>1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nice</dc:creator>
  <cp:lastModifiedBy>Janice</cp:lastModifiedBy>
  <cp:revision>2</cp:revision>
  <dcterms:created xsi:type="dcterms:W3CDTF">2011-04-07T14:35:31Z</dcterms:created>
  <dcterms:modified xsi:type="dcterms:W3CDTF">2011-04-07T14:36:25Z</dcterms:modified>
</cp:coreProperties>
</file>